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2572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381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6896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5237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6121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4224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2520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2002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9319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9949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7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163FF-6261-461D-AC0C-97C7144C1B17}" type="datetimeFigureOut">
              <a:rPr lang="zh-CN" altLang="en-US" smtClean="0"/>
              <a:t>2024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B02F8A-F59C-45DA-AA51-E069342ACC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7799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70" t="4259" r="20372" b="20926"/>
          <a:stretch/>
        </p:blipFill>
        <p:spPr>
          <a:xfrm>
            <a:off x="513587" y="2103120"/>
            <a:ext cx="3746455" cy="2888488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513587" y="1595289"/>
            <a:ext cx="1563248" cy="5078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CC-60d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4584699" y="1595288"/>
            <a:ext cx="1678665" cy="5078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CC-120d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5" t="28148" r="6364" b="13518"/>
          <a:stretch/>
        </p:blipFill>
        <p:spPr>
          <a:xfrm>
            <a:off x="4584699" y="2103120"/>
            <a:ext cx="3974085" cy="288441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83441" y="2103119"/>
            <a:ext cx="2601418" cy="2884417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8883441" y="1595288"/>
            <a:ext cx="1678665" cy="5078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CC-180d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439164" y="5180183"/>
            <a:ext cx="10615931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Pathological lesions observed in SPF chicken challenged with the MDV vvMD5 strain.</a:t>
            </a:r>
            <a:endParaRPr lang="zh-CN" altLang="zh-CN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8097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2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DELL</cp:lastModifiedBy>
  <cp:revision>2</cp:revision>
  <dcterms:created xsi:type="dcterms:W3CDTF">2024-11-24T12:52:12Z</dcterms:created>
  <dcterms:modified xsi:type="dcterms:W3CDTF">2024-11-25T06:40:52Z</dcterms:modified>
</cp:coreProperties>
</file>